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ric Fleegler" initials="EF" lastIdx="2" clrIdx="0">
    <p:extLst>
      <p:ext uri="{19B8F6BF-5375-455C-9EA6-DF929625EA0E}">
        <p15:presenceInfo xmlns:p15="http://schemas.microsoft.com/office/powerpoint/2012/main" userId="Eric Fleeg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86"/>
    <p:restoredTop sz="96327"/>
  </p:normalViewPr>
  <p:slideViewPr>
    <p:cSldViewPr snapToGrid="0" snapToObjects="1">
      <p:cViewPr varScale="1">
        <p:scale>
          <a:sx n="116" d="100"/>
          <a:sy n="116" d="100"/>
        </p:scale>
        <p:origin x="4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mainguedj/Desktop/Data%20request%20CRIT/Data20BaseGeleeArticle1/1-Fracture/TableanalgesiaFractur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mainguedj/Desktop/Data%20request%20CRIT/Data20BaseGeleeArticle1/1-Fracture/TableanalgesiaFractur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mainguedj/Desktop/Data%20request%20CRIT/Data20BaseGeleeArticle1/1-Fracture/TableanalgesiaFractur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mainguedj/Desktop/Data%20request%20CRIT/Data20BaseGeleeArticle1/1-Fracture/TableanalgesiaFractur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mainguedj/Desktop/Data%20request%20CRIT/Data20BaseGeleeArticle1/1-Fracture/TableanalgesiaFractur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mainguedj/Desktop/Data%20request%20CRIT/Data20BaseGeleeArticle1/1-Fracture/TableanalgesiaFractur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dirty="0" err="1"/>
              <a:t>Only</a:t>
            </a:r>
            <a:r>
              <a:rPr lang="fr-FR" dirty="0"/>
              <a:t> non </a:t>
            </a:r>
            <a:r>
              <a:rPr lang="fr-FR" dirty="0" err="1"/>
              <a:t>opioid</a:t>
            </a:r>
            <a:r>
              <a:rPr lang="fr-FR" dirty="0"/>
              <a:t> </a:t>
            </a:r>
            <a:r>
              <a:rPr lang="fr-FR" dirty="0" err="1"/>
              <a:t>analgesia</a:t>
            </a:r>
            <a:endParaRPr lang="fr-FR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AppyByRace!$A$21:$B$21</c:f>
              <c:strCache>
                <c:ptCount val="2"/>
                <c:pt idx="0">
                  <c:v>Non opioid</c:v>
                </c:pt>
                <c:pt idx="1">
                  <c:v>WN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AppyByRace!$C$20:$F$20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21:$F$21</c:f>
              <c:numCache>
                <c:formatCode>0.0%</c:formatCode>
                <c:ptCount val="4"/>
                <c:pt idx="0">
                  <c:v>0.24832209999999999</c:v>
                </c:pt>
                <c:pt idx="1">
                  <c:v>0.24610589999999999</c:v>
                </c:pt>
                <c:pt idx="2">
                  <c:v>0.27154309999999998</c:v>
                </c:pt>
                <c:pt idx="3">
                  <c:v>0.21485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D5E-954F-9DA0-9EF73127F05F}"/>
            </c:ext>
          </c:extLst>
        </c:ser>
        <c:ser>
          <c:idx val="1"/>
          <c:order val="1"/>
          <c:tx>
            <c:strRef>
              <c:f>AppyByRace!$A$22:$B$22</c:f>
              <c:strCache>
                <c:ptCount val="2"/>
                <c:pt idx="0">
                  <c:v>Non opioid</c:v>
                </c:pt>
                <c:pt idx="1">
                  <c:v>Black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AppyByRace!$C$20:$F$20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22:$F$22</c:f>
              <c:numCache>
                <c:formatCode>0.0%</c:formatCode>
                <c:ptCount val="4"/>
                <c:pt idx="0">
                  <c:v>0.36734689999999998</c:v>
                </c:pt>
                <c:pt idx="1">
                  <c:v>0.3541667</c:v>
                </c:pt>
                <c:pt idx="2">
                  <c:v>0.3649635</c:v>
                </c:pt>
                <c:pt idx="3">
                  <c:v>0.3103447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D5E-954F-9DA0-9EF73127F05F}"/>
            </c:ext>
          </c:extLst>
        </c:ser>
        <c:ser>
          <c:idx val="2"/>
          <c:order val="2"/>
          <c:tx>
            <c:strRef>
              <c:f>AppyByRace!$A$23:$B$23</c:f>
              <c:strCache>
                <c:ptCount val="2"/>
                <c:pt idx="0">
                  <c:v>Non opioid</c:v>
                </c:pt>
                <c:pt idx="1">
                  <c:v>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AppyByRace!$C$20:$F$20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23:$F$23</c:f>
              <c:numCache>
                <c:formatCode>0.0%</c:formatCode>
                <c:ptCount val="4"/>
                <c:pt idx="0">
                  <c:v>0.34693879999999999</c:v>
                </c:pt>
                <c:pt idx="1">
                  <c:v>0.2676056</c:v>
                </c:pt>
                <c:pt idx="2">
                  <c:v>0.37656899999999999</c:v>
                </c:pt>
                <c:pt idx="3">
                  <c:v>0.3266219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D5E-954F-9DA0-9EF73127F0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97834287"/>
        <c:axId val="1061085167"/>
      </c:lineChart>
      <c:catAx>
        <c:axId val="9978342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1085167"/>
        <c:crosses val="autoZero"/>
        <c:auto val="1"/>
        <c:lblAlgn val="ctr"/>
        <c:lblOffset val="100"/>
        <c:noMultiLvlLbl val="0"/>
      </c:catAx>
      <c:valAx>
        <c:axId val="1061085167"/>
        <c:scaling>
          <c:orientation val="minMax"/>
          <c:max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978342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dirty="0"/>
              <a:t>No</a:t>
            </a:r>
            <a:r>
              <a:rPr lang="fr-FR" baseline="0" dirty="0"/>
              <a:t> </a:t>
            </a:r>
            <a:r>
              <a:rPr lang="fr-FR" baseline="0" dirty="0" err="1"/>
              <a:t>analgesia</a:t>
            </a:r>
            <a:endParaRPr lang="fr-FR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AppyByRace!$A$26:$B$26</c:f>
              <c:strCache>
                <c:ptCount val="2"/>
                <c:pt idx="0">
                  <c:v>No analgesia</c:v>
                </c:pt>
                <c:pt idx="1">
                  <c:v>WN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AppyByRace!$C$25:$F$25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26:$F$26</c:f>
              <c:numCache>
                <c:formatCode>0.0%</c:formatCode>
                <c:ptCount val="4"/>
                <c:pt idx="0">
                  <c:v>0.57718119999999995</c:v>
                </c:pt>
                <c:pt idx="1">
                  <c:v>0.5514019</c:v>
                </c:pt>
                <c:pt idx="2">
                  <c:v>0.42084169999999999</c:v>
                </c:pt>
                <c:pt idx="3">
                  <c:v>0.2662857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709-CE41-A891-447FFC144142}"/>
            </c:ext>
          </c:extLst>
        </c:ser>
        <c:ser>
          <c:idx val="1"/>
          <c:order val="1"/>
          <c:tx>
            <c:strRef>
              <c:f>AppyByRace!$A$27:$B$27</c:f>
              <c:strCache>
                <c:ptCount val="2"/>
                <c:pt idx="0">
                  <c:v>No analgesia</c:v>
                </c:pt>
                <c:pt idx="1">
                  <c:v>Black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AppyByRace!$C$25:$F$25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27:$F$27</c:f>
              <c:numCache>
                <c:formatCode>0.0%</c:formatCode>
                <c:ptCount val="4"/>
                <c:pt idx="0">
                  <c:v>0.57142859999999995</c:v>
                </c:pt>
                <c:pt idx="1">
                  <c:v>0.3958333</c:v>
                </c:pt>
                <c:pt idx="2">
                  <c:v>0.43065690000000001</c:v>
                </c:pt>
                <c:pt idx="3">
                  <c:v>0.2456897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709-CE41-A891-447FFC144142}"/>
            </c:ext>
          </c:extLst>
        </c:ser>
        <c:ser>
          <c:idx val="2"/>
          <c:order val="2"/>
          <c:tx>
            <c:strRef>
              <c:f>AppyByRace!$A$28:$B$28</c:f>
              <c:strCache>
                <c:ptCount val="2"/>
                <c:pt idx="0">
                  <c:v>No analgesia</c:v>
                </c:pt>
                <c:pt idx="1">
                  <c:v>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AppyByRace!$C$25:$F$25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28:$F$28</c:f>
              <c:numCache>
                <c:formatCode>0.0%</c:formatCode>
                <c:ptCount val="4"/>
                <c:pt idx="0">
                  <c:v>0.5</c:v>
                </c:pt>
                <c:pt idx="1">
                  <c:v>0.5492958</c:v>
                </c:pt>
                <c:pt idx="2">
                  <c:v>0.36401670000000003</c:v>
                </c:pt>
                <c:pt idx="3">
                  <c:v>0.221476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709-CE41-A891-447FFC1441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0902015"/>
        <c:axId val="921661247"/>
      </c:lineChart>
      <c:catAx>
        <c:axId val="9209020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21661247"/>
        <c:crosses val="autoZero"/>
        <c:auto val="1"/>
        <c:lblAlgn val="ctr"/>
        <c:lblOffset val="100"/>
        <c:noMultiLvlLbl val="0"/>
      </c:catAx>
      <c:valAx>
        <c:axId val="92166124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209020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dirty="0" err="1"/>
              <a:t>Opioid</a:t>
            </a:r>
            <a:r>
              <a:rPr lang="fr-FR" dirty="0"/>
              <a:t> </a:t>
            </a:r>
            <a:r>
              <a:rPr lang="fr-FR" dirty="0" err="1"/>
              <a:t>analgesia</a:t>
            </a:r>
            <a:endParaRPr lang="fr-FR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AppyByRace!$A$16:$B$16</c:f>
              <c:strCache>
                <c:ptCount val="2"/>
                <c:pt idx="0">
                  <c:v>Opioid</c:v>
                </c:pt>
                <c:pt idx="1">
                  <c:v>WN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AppyByRace!$C$15:$F$15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16:$F$16</c:f>
              <c:numCache>
                <c:formatCode>0.0%</c:formatCode>
                <c:ptCount val="4"/>
                <c:pt idx="0">
                  <c:v>0.1744966</c:v>
                </c:pt>
                <c:pt idx="1">
                  <c:v>0.20249220000000001</c:v>
                </c:pt>
                <c:pt idx="2">
                  <c:v>0.30761519999999998</c:v>
                </c:pt>
                <c:pt idx="3">
                  <c:v>0.5188570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5B-484F-BAC1-1C4816AFAA9F}"/>
            </c:ext>
          </c:extLst>
        </c:ser>
        <c:ser>
          <c:idx val="1"/>
          <c:order val="1"/>
          <c:tx>
            <c:strRef>
              <c:f>AppyByRace!$A$17:$B$17</c:f>
              <c:strCache>
                <c:ptCount val="2"/>
                <c:pt idx="0">
                  <c:v>Opioid</c:v>
                </c:pt>
                <c:pt idx="1">
                  <c:v>Black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AppyByRace!$C$15:$F$15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17:$F$17</c:f>
              <c:numCache>
                <c:formatCode>0.0%</c:formatCode>
                <c:ptCount val="4"/>
                <c:pt idx="0">
                  <c:v>6.1224500000000001E-2</c:v>
                </c:pt>
                <c:pt idx="1">
                  <c:v>0.25</c:v>
                </c:pt>
                <c:pt idx="2">
                  <c:v>0.20437959999999999</c:v>
                </c:pt>
                <c:pt idx="3">
                  <c:v>0.4439655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95B-484F-BAC1-1C4816AFAA9F}"/>
            </c:ext>
          </c:extLst>
        </c:ser>
        <c:ser>
          <c:idx val="2"/>
          <c:order val="2"/>
          <c:tx>
            <c:strRef>
              <c:f>AppyByRace!$A$18:$B$18</c:f>
              <c:strCache>
                <c:ptCount val="2"/>
                <c:pt idx="0">
                  <c:v>Opioid</c:v>
                </c:pt>
                <c:pt idx="1">
                  <c:v>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AppyByRace!$C$15:$F$15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AppyByRace!$C$18:$F$18</c:f>
              <c:numCache>
                <c:formatCode>0.0%</c:formatCode>
                <c:ptCount val="4"/>
                <c:pt idx="0">
                  <c:v>0.15306120000000001</c:v>
                </c:pt>
                <c:pt idx="1">
                  <c:v>0.1830986</c:v>
                </c:pt>
                <c:pt idx="2">
                  <c:v>0.25941419999999998</c:v>
                </c:pt>
                <c:pt idx="3">
                  <c:v>0.4519016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95B-484F-BAC1-1C4816AFAA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61702623"/>
        <c:axId val="1063140207"/>
      </c:lineChart>
      <c:catAx>
        <c:axId val="10617026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3140207"/>
        <c:crosses val="autoZero"/>
        <c:auto val="1"/>
        <c:lblAlgn val="ctr"/>
        <c:lblOffset val="100"/>
        <c:noMultiLvlLbl val="0"/>
      </c:catAx>
      <c:valAx>
        <c:axId val="1063140207"/>
        <c:scaling>
          <c:orientation val="minMax"/>
          <c:max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1702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No analgesi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FBy race'!$A$27:$B$27</c:f>
              <c:strCache>
                <c:ptCount val="2"/>
                <c:pt idx="0">
                  <c:v>No analgesia</c:v>
                </c:pt>
                <c:pt idx="1">
                  <c:v>WN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FBy race'!$C$26:$F$26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27:$F$27</c:f>
              <c:numCache>
                <c:formatCode>0%</c:formatCode>
                <c:ptCount val="4"/>
                <c:pt idx="0">
                  <c:v>0.60336299999999998</c:v>
                </c:pt>
                <c:pt idx="1">
                  <c:v>0.50413220000000003</c:v>
                </c:pt>
                <c:pt idx="2">
                  <c:v>0.30077429999999999</c:v>
                </c:pt>
                <c:pt idx="3">
                  <c:v>0.12521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589-814A-8366-9512DABFB94B}"/>
            </c:ext>
          </c:extLst>
        </c:ser>
        <c:ser>
          <c:idx val="1"/>
          <c:order val="1"/>
          <c:tx>
            <c:strRef>
              <c:f>'FBy race'!$A$28:$B$28</c:f>
              <c:strCache>
                <c:ptCount val="2"/>
                <c:pt idx="0">
                  <c:v>No analgesia</c:v>
                </c:pt>
                <c:pt idx="1">
                  <c:v>Black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FBy race'!$C$26:$F$26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28:$F$28</c:f>
              <c:numCache>
                <c:formatCode>0%</c:formatCode>
                <c:ptCount val="4"/>
                <c:pt idx="0">
                  <c:v>0.61290319999999998</c:v>
                </c:pt>
                <c:pt idx="1">
                  <c:v>0.41322310000000001</c:v>
                </c:pt>
                <c:pt idx="2">
                  <c:v>0.22072069999999999</c:v>
                </c:pt>
                <c:pt idx="3">
                  <c:v>6.4406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589-814A-8366-9512DABFB94B}"/>
            </c:ext>
          </c:extLst>
        </c:ser>
        <c:ser>
          <c:idx val="2"/>
          <c:order val="2"/>
          <c:tx>
            <c:strRef>
              <c:f>'FBy race'!$A$29:$B$29</c:f>
              <c:strCache>
                <c:ptCount val="2"/>
                <c:pt idx="0">
                  <c:v>No analgesia</c:v>
                </c:pt>
                <c:pt idx="1">
                  <c:v>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FBy race'!$C$26:$F$26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29:$F$29</c:f>
              <c:numCache>
                <c:formatCode>0%</c:formatCode>
                <c:ptCount val="4"/>
                <c:pt idx="0">
                  <c:v>0.61458299999999999</c:v>
                </c:pt>
                <c:pt idx="1">
                  <c:v>0.36746990000000002</c:v>
                </c:pt>
                <c:pt idx="2">
                  <c:v>0.2491582</c:v>
                </c:pt>
                <c:pt idx="3">
                  <c:v>0.12121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589-814A-8366-9512DABFB9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61451279"/>
        <c:axId val="996679231"/>
      </c:lineChart>
      <c:catAx>
        <c:axId val="10614512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96679231"/>
        <c:crosses val="autoZero"/>
        <c:auto val="1"/>
        <c:lblAlgn val="ctr"/>
        <c:lblOffset val="100"/>
        <c:noMultiLvlLbl val="0"/>
      </c:catAx>
      <c:valAx>
        <c:axId val="9966792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14512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dirty="0" err="1"/>
              <a:t>Only</a:t>
            </a:r>
            <a:r>
              <a:rPr lang="fr-FR" dirty="0"/>
              <a:t> non </a:t>
            </a:r>
            <a:r>
              <a:rPr lang="fr-FR" dirty="0" err="1"/>
              <a:t>opioid</a:t>
            </a:r>
            <a:r>
              <a:rPr lang="fr-FR" dirty="0"/>
              <a:t> </a:t>
            </a:r>
            <a:r>
              <a:rPr lang="fr-FR" dirty="0" err="1"/>
              <a:t>analgesia</a:t>
            </a:r>
            <a:endParaRPr lang="fr-FR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FBy race'!$A$22:$B$22</c:f>
              <c:strCache>
                <c:ptCount val="2"/>
                <c:pt idx="0">
                  <c:v>Non opioid</c:v>
                </c:pt>
                <c:pt idx="1">
                  <c:v>WN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FBy race'!$C$21:$F$21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22:$F$22</c:f>
              <c:numCache>
                <c:formatCode>0.0%</c:formatCode>
                <c:ptCount val="4"/>
                <c:pt idx="0">
                  <c:v>0.181008</c:v>
                </c:pt>
                <c:pt idx="1">
                  <c:v>0.19651060000000001</c:v>
                </c:pt>
                <c:pt idx="2">
                  <c:v>0.28528890000000001</c:v>
                </c:pt>
                <c:pt idx="3">
                  <c:v>0.2924528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97E-854E-A0C3-DB2AC194054A}"/>
            </c:ext>
          </c:extLst>
        </c:ser>
        <c:ser>
          <c:idx val="1"/>
          <c:order val="1"/>
          <c:tx>
            <c:strRef>
              <c:f>'FBy race'!$A$23:$B$23</c:f>
              <c:strCache>
                <c:ptCount val="2"/>
                <c:pt idx="0">
                  <c:v>Non opioid</c:v>
                </c:pt>
                <c:pt idx="1">
                  <c:v>Black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FBy race'!$C$21:$F$21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23:$F$23</c:f>
              <c:numCache>
                <c:formatCode>0.0%</c:formatCode>
                <c:ptCount val="4"/>
                <c:pt idx="0">
                  <c:v>0.233871</c:v>
                </c:pt>
                <c:pt idx="1">
                  <c:v>0.38842979999999999</c:v>
                </c:pt>
                <c:pt idx="2">
                  <c:v>0.57207209999999997</c:v>
                </c:pt>
                <c:pt idx="3">
                  <c:v>0.48813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97E-854E-A0C3-DB2AC194054A}"/>
            </c:ext>
          </c:extLst>
        </c:ser>
        <c:ser>
          <c:idx val="2"/>
          <c:order val="2"/>
          <c:tx>
            <c:strRef>
              <c:f>'FBy race'!$A$24:$B$24</c:f>
              <c:strCache>
                <c:ptCount val="2"/>
                <c:pt idx="0">
                  <c:v>Non opioid</c:v>
                </c:pt>
                <c:pt idx="1">
                  <c:v>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FBy race'!$C$21:$F$21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24:$F$24</c:f>
              <c:numCache>
                <c:formatCode>0.0%</c:formatCode>
                <c:ptCount val="4"/>
                <c:pt idx="0">
                  <c:v>0.2395833</c:v>
                </c:pt>
                <c:pt idx="1">
                  <c:v>0.36144579999999998</c:v>
                </c:pt>
                <c:pt idx="2">
                  <c:v>0.47474749999999999</c:v>
                </c:pt>
                <c:pt idx="3">
                  <c:v>0.4969697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97E-854E-A0C3-DB2AC19405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83732879"/>
        <c:axId val="1061486671"/>
      </c:lineChart>
      <c:catAx>
        <c:axId val="10837328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1486671"/>
        <c:crosses val="autoZero"/>
        <c:auto val="1"/>
        <c:lblAlgn val="ctr"/>
        <c:lblOffset val="100"/>
        <c:noMultiLvlLbl val="0"/>
      </c:catAx>
      <c:valAx>
        <c:axId val="10614866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837328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dirty="0" err="1"/>
              <a:t>Opioid</a:t>
            </a:r>
            <a:r>
              <a:rPr lang="fr-FR" dirty="0"/>
              <a:t> </a:t>
            </a:r>
            <a:r>
              <a:rPr lang="fr-FR" dirty="0" err="1"/>
              <a:t>analgesia</a:t>
            </a:r>
            <a:endParaRPr lang="fr-FR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FBy race'!$A$17:$B$17</c:f>
              <c:strCache>
                <c:ptCount val="2"/>
                <c:pt idx="0">
                  <c:v>Opioid</c:v>
                </c:pt>
                <c:pt idx="1">
                  <c:v>WN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FBy race'!$C$16:$F$16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17:$F$17</c:f>
              <c:numCache>
                <c:formatCode>0.0%</c:formatCode>
                <c:ptCount val="4"/>
                <c:pt idx="0">
                  <c:v>0.21562809999999999</c:v>
                </c:pt>
                <c:pt idx="1">
                  <c:v>0.29935719999999999</c:v>
                </c:pt>
                <c:pt idx="2">
                  <c:v>0.4139369</c:v>
                </c:pt>
                <c:pt idx="3">
                  <c:v>0.5823327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624-234F-BA5A-9145D19C5272}"/>
            </c:ext>
          </c:extLst>
        </c:ser>
        <c:ser>
          <c:idx val="1"/>
          <c:order val="1"/>
          <c:tx>
            <c:strRef>
              <c:f>'FBy race'!$A$18:$B$18</c:f>
              <c:strCache>
                <c:ptCount val="2"/>
                <c:pt idx="0">
                  <c:v>Opioid</c:v>
                </c:pt>
                <c:pt idx="1">
                  <c:v>Black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FBy race'!$C$16:$F$16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18:$F$18</c:f>
              <c:numCache>
                <c:formatCode>0.0%</c:formatCode>
                <c:ptCount val="4"/>
                <c:pt idx="0">
                  <c:v>0.1532258</c:v>
                </c:pt>
                <c:pt idx="1">
                  <c:v>0.1983471</c:v>
                </c:pt>
                <c:pt idx="2">
                  <c:v>0.20720720000000001</c:v>
                </c:pt>
                <c:pt idx="3">
                  <c:v>0.4474576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624-234F-BA5A-9145D19C5272}"/>
            </c:ext>
          </c:extLst>
        </c:ser>
        <c:ser>
          <c:idx val="2"/>
          <c:order val="2"/>
          <c:tx>
            <c:strRef>
              <c:f>'FBy race'!$A$19:$B$19</c:f>
              <c:strCache>
                <c:ptCount val="2"/>
                <c:pt idx="0">
                  <c:v>Opioid</c:v>
                </c:pt>
                <c:pt idx="1">
                  <c:v>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FBy race'!$C$16:$F$16</c:f>
              <c:strCache>
                <c:ptCount val="4"/>
                <c:pt idx="0">
                  <c:v>None</c:v>
                </c:pt>
                <c:pt idx="1">
                  <c:v>Mild</c:v>
                </c:pt>
                <c:pt idx="2">
                  <c:v>Moderate</c:v>
                </c:pt>
                <c:pt idx="3">
                  <c:v>Severe</c:v>
                </c:pt>
              </c:strCache>
            </c:strRef>
          </c:cat>
          <c:val>
            <c:numRef>
              <c:f>'FBy race'!$C$19:$F$19</c:f>
              <c:numCache>
                <c:formatCode>0.0%</c:formatCode>
                <c:ptCount val="4"/>
                <c:pt idx="0">
                  <c:v>0.1458333</c:v>
                </c:pt>
                <c:pt idx="1">
                  <c:v>0.2710843</c:v>
                </c:pt>
                <c:pt idx="2">
                  <c:v>0.27609430000000001</c:v>
                </c:pt>
                <c:pt idx="3">
                  <c:v>0.38181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624-234F-BA5A-9145D19C52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62030575"/>
        <c:axId val="1061616895"/>
      </c:lineChart>
      <c:catAx>
        <c:axId val="10620305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1616895"/>
        <c:crosses val="autoZero"/>
        <c:auto val="1"/>
        <c:lblAlgn val="ctr"/>
        <c:lblOffset val="100"/>
        <c:noMultiLvlLbl val="0"/>
      </c:catAx>
      <c:valAx>
        <c:axId val="10616168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20305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AF1D77-38D3-124E-A545-80EAAC5ED030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848EFC-B8C2-6A4A-AF28-46F9082822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0831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814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888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8777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2182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7629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8318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2327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9683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1119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3151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8700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3536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CD07F2B3-E4F0-0E4D-B4E5-80FC1181A1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9557476"/>
              </p:ext>
            </p:extLst>
          </p:nvPr>
        </p:nvGraphicFramePr>
        <p:xfrm>
          <a:off x="4407960" y="3532243"/>
          <a:ext cx="3839633" cy="2707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1FEB8B50-0559-304D-A5A0-209E586CDD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120516"/>
              </p:ext>
            </p:extLst>
          </p:nvPr>
        </p:nvGraphicFramePr>
        <p:xfrm>
          <a:off x="342898" y="3532243"/>
          <a:ext cx="3839633" cy="2707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2A6AD768-67B8-C942-A9B3-D528BFD60F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6533171"/>
              </p:ext>
            </p:extLst>
          </p:nvPr>
        </p:nvGraphicFramePr>
        <p:xfrm>
          <a:off x="8397868" y="3532244"/>
          <a:ext cx="3861863" cy="2707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Graphique 8">
            <a:extLst>
              <a:ext uri="{FF2B5EF4-FFF2-40B4-BE49-F238E27FC236}">
                <a16:creationId xmlns:a16="http://schemas.microsoft.com/office/drawing/2014/main" id="{E05EEA45-E8AE-CB4E-B0FF-83B81C7302B2}"/>
              </a:ext>
            </a:extLst>
          </p:cNvPr>
          <p:cNvGraphicFramePr>
            <a:graphicFrameLocks/>
          </p:cNvGraphicFramePr>
          <p:nvPr/>
        </p:nvGraphicFramePr>
        <p:xfrm>
          <a:off x="342898" y="444322"/>
          <a:ext cx="3839633" cy="2707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B7EEAA65-FC7B-994C-BBCE-727AC74F5C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7677166"/>
              </p:ext>
            </p:extLst>
          </p:nvPr>
        </p:nvGraphicFramePr>
        <p:xfrm>
          <a:off x="4407960" y="444322"/>
          <a:ext cx="3839633" cy="2707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Graphique 11">
            <a:extLst>
              <a:ext uri="{FF2B5EF4-FFF2-40B4-BE49-F238E27FC236}">
                <a16:creationId xmlns:a16="http://schemas.microsoft.com/office/drawing/2014/main" id="{2FC9364F-DF1E-D745-8B96-5558A169A0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3266021"/>
              </p:ext>
            </p:extLst>
          </p:nvPr>
        </p:nvGraphicFramePr>
        <p:xfrm>
          <a:off x="8281460" y="444322"/>
          <a:ext cx="3861863" cy="2707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ZoneTexte 12">
            <a:extLst>
              <a:ext uri="{FF2B5EF4-FFF2-40B4-BE49-F238E27FC236}">
                <a16:creationId xmlns:a16="http://schemas.microsoft.com/office/drawing/2014/main" id="{2DF6E9FC-B9D9-DF42-8EDF-2B9E5FCAEACB}"/>
              </a:ext>
            </a:extLst>
          </p:cNvPr>
          <p:cNvSpPr txBox="1"/>
          <p:nvPr/>
        </p:nvSpPr>
        <p:spPr>
          <a:xfrm>
            <a:off x="101771" y="187520"/>
            <a:ext cx="4741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err="1"/>
              <a:t>Limb</a:t>
            </a:r>
            <a:r>
              <a:rPr lang="fr-FR" sz="1600" b="1" dirty="0"/>
              <a:t> fracture </a:t>
            </a:r>
            <a:r>
              <a:rPr lang="fr-FR" sz="1600" b="1" dirty="0" err="1"/>
              <a:t>cohort</a:t>
            </a:r>
            <a:endParaRPr lang="fr-FR" sz="1600" b="1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8ED31C8-85DD-5B43-A519-90EEABCF2D68}"/>
              </a:ext>
            </a:extLst>
          </p:cNvPr>
          <p:cNvSpPr txBox="1"/>
          <p:nvPr/>
        </p:nvSpPr>
        <p:spPr>
          <a:xfrm>
            <a:off x="2467" y="3332875"/>
            <a:ext cx="4741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err="1"/>
              <a:t>Suspected</a:t>
            </a:r>
            <a:r>
              <a:rPr lang="fr-FR" sz="1600" b="1" dirty="0"/>
              <a:t> </a:t>
            </a:r>
            <a:r>
              <a:rPr lang="fr-FR" sz="1600" b="1" dirty="0" err="1"/>
              <a:t>appendicitis</a:t>
            </a:r>
            <a:r>
              <a:rPr lang="fr-FR" sz="1600" b="1" dirty="0"/>
              <a:t> </a:t>
            </a:r>
            <a:r>
              <a:rPr lang="fr-FR" sz="1600" b="1" dirty="0" err="1"/>
              <a:t>cohort</a:t>
            </a:r>
            <a:endParaRPr lang="fr-FR" sz="1600" b="1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35188D9-FC13-004A-A128-231E45C27A39}"/>
              </a:ext>
            </a:extLst>
          </p:cNvPr>
          <p:cNvSpPr txBox="1"/>
          <p:nvPr/>
        </p:nvSpPr>
        <p:spPr>
          <a:xfrm>
            <a:off x="2" y="689852"/>
            <a:ext cx="400110" cy="253153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roportion of </a:t>
            </a:r>
            <a:r>
              <a:rPr lang="fr-FR" sz="1400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children</a:t>
            </a:r>
            <a:endParaRPr lang="fr-FR" sz="14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02C21A2-553F-BA42-8764-C2465D152989}"/>
              </a:ext>
            </a:extLst>
          </p:cNvPr>
          <p:cNvSpPr txBox="1"/>
          <p:nvPr/>
        </p:nvSpPr>
        <p:spPr>
          <a:xfrm>
            <a:off x="-57212" y="3620085"/>
            <a:ext cx="400110" cy="253153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roportion of </a:t>
            </a:r>
            <a:r>
              <a:rPr lang="fr-FR" sz="1400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children</a:t>
            </a:r>
            <a:endParaRPr lang="fr-FR" sz="14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681CC213-CD96-274B-8897-ADFEB28C8DC2}"/>
              </a:ext>
            </a:extLst>
          </p:cNvPr>
          <p:cNvSpPr txBox="1"/>
          <p:nvPr/>
        </p:nvSpPr>
        <p:spPr>
          <a:xfrm>
            <a:off x="3393604" y="814896"/>
            <a:ext cx="4001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B5763C7-98BA-7F4B-9B19-6D27E02FCD47}"/>
              </a:ext>
            </a:extLst>
          </p:cNvPr>
          <p:cNvSpPr txBox="1"/>
          <p:nvPr/>
        </p:nvSpPr>
        <p:spPr>
          <a:xfrm>
            <a:off x="2604678" y="805445"/>
            <a:ext cx="4001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9BD4BE97-EF39-6F47-BD93-722FFC9F220E}"/>
              </a:ext>
            </a:extLst>
          </p:cNvPr>
          <p:cNvSpPr txBox="1"/>
          <p:nvPr/>
        </p:nvSpPr>
        <p:spPr>
          <a:xfrm>
            <a:off x="1815751" y="946380"/>
            <a:ext cx="4001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3"/>
                </a:solidFill>
              </a:rPr>
              <a:t>**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9508744D-6E31-D74E-811D-85C2A11FED94}"/>
              </a:ext>
            </a:extLst>
          </p:cNvPr>
          <p:cNvSpPr txBox="1"/>
          <p:nvPr/>
        </p:nvSpPr>
        <p:spPr>
          <a:xfrm>
            <a:off x="7481899" y="783038"/>
            <a:ext cx="489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*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F82A1410-4EAC-3844-AD70-59239C32DED2}"/>
              </a:ext>
            </a:extLst>
          </p:cNvPr>
          <p:cNvSpPr txBox="1"/>
          <p:nvPr/>
        </p:nvSpPr>
        <p:spPr>
          <a:xfrm>
            <a:off x="6692974" y="783040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*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767ADDC-BB4D-EE4C-8089-47FE9BEC5F94}"/>
              </a:ext>
            </a:extLst>
          </p:cNvPr>
          <p:cNvSpPr txBox="1"/>
          <p:nvPr/>
        </p:nvSpPr>
        <p:spPr>
          <a:xfrm>
            <a:off x="6692973" y="936927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3"/>
                </a:solidFill>
              </a:rPr>
              <a:t>***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CD862F33-5DAB-F240-998C-A476B359235D}"/>
              </a:ext>
            </a:extLst>
          </p:cNvPr>
          <p:cNvSpPr txBox="1"/>
          <p:nvPr/>
        </p:nvSpPr>
        <p:spPr>
          <a:xfrm>
            <a:off x="7481899" y="936928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3"/>
                </a:solidFill>
              </a:rPr>
              <a:t>***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581D0A73-C3D9-1946-9638-0CFAEBD50AD3}"/>
              </a:ext>
            </a:extLst>
          </p:cNvPr>
          <p:cNvSpPr txBox="1"/>
          <p:nvPr/>
        </p:nvSpPr>
        <p:spPr>
          <a:xfrm>
            <a:off x="5847728" y="783039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*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9EF22DA3-E0E9-5D48-BAC8-E890297F687E}"/>
              </a:ext>
            </a:extLst>
          </p:cNvPr>
          <p:cNvSpPr txBox="1"/>
          <p:nvPr/>
        </p:nvSpPr>
        <p:spPr>
          <a:xfrm>
            <a:off x="5847727" y="936926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3"/>
                </a:solidFill>
              </a:rPr>
              <a:t>***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37A5C3E-6DE6-854F-BA0F-D03995768F25}"/>
              </a:ext>
            </a:extLst>
          </p:cNvPr>
          <p:cNvSpPr txBox="1"/>
          <p:nvPr/>
        </p:nvSpPr>
        <p:spPr>
          <a:xfrm>
            <a:off x="11324621" y="792490"/>
            <a:ext cx="489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*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5452C5BF-ECF3-0D4D-BD65-B3531546029B}"/>
              </a:ext>
            </a:extLst>
          </p:cNvPr>
          <p:cNvSpPr txBox="1"/>
          <p:nvPr/>
        </p:nvSpPr>
        <p:spPr>
          <a:xfrm>
            <a:off x="10535696" y="792492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**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60F937E3-AFC7-6348-98CF-C37CE7DCAFC8}"/>
              </a:ext>
            </a:extLst>
          </p:cNvPr>
          <p:cNvSpPr txBox="1"/>
          <p:nvPr/>
        </p:nvSpPr>
        <p:spPr>
          <a:xfrm>
            <a:off x="10535695" y="946379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3"/>
                </a:solidFill>
              </a:rPr>
              <a:t>***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9EC412B0-E2F9-C04B-9BB8-6B66ACF7EC66}"/>
              </a:ext>
            </a:extLst>
          </p:cNvPr>
          <p:cNvSpPr txBox="1"/>
          <p:nvPr/>
        </p:nvSpPr>
        <p:spPr>
          <a:xfrm>
            <a:off x="11324621" y="946380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3"/>
                </a:solidFill>
              </a:rPr>
              <a:t>***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1F4F1735-14CA-5946-9B05-AE1AD9BE90ED}"/>
              </a:ext>
            </a:extLst>
          </p:cNvPr>
          <p:cNvSpPr txBox="1"/>
          <p:nvPr/>
        </p:nvSpPr>
        <p:spPr>
          <a:xfrm>
            <a:off x="9690450" y="792491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2"/>
                </a:solidFill>
              </a:rPr>
              <a:t>*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714F222A-D019-E045-AB5C-685E6E379200}"/>
              </a:ext>
            </a:extLst>
          </p:cNvPr>
          <p:cNvSpPr txBox="1"/>
          <p:nvPr/>
        </p:nvSpPr>
        <p:spPr>
          <a:xfrm>
            <a:off x="8957795" y="953004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3"/>
                </a:solidFill>
              </a:rPr>
              <a:t>*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DB9AD626-B64B-3E44-B640-E63CB4A42C8C}"/>
              </a:ext>
            </a:extLst>
          </p:cNvPr>
          <p:cNvSpPr txBox="1"/>
          <p:nvPr/>
        </p:nvSpPr>
        <p:spPr>
          <a:xfrm>
            <a:off x="7447299" y="3846996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2"/>
                </a:solidFill>
              </a:rPr>
              <a:t>**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32717291-B13D-D544-9CC6-65760AC940D8}"/>
              </a:ext>
            </a:extLst>
          </p:cNvPr>
          <p:cNvSpPr txBox="1"/>
          <p:nvPr/>
        </p:nvSpPr>
        <p:spPr>
          <a:xfrm>
            <a:off x="6658374" y="3846998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2"/>
                </a:solidFill>
              </a:rPr>
              <a:t>*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276EDF58-CED8-EB43-9ABC-0A4FCFE9039E}"/>
              </a:ext>
            </a:extLst>
          </p:cNvPr>
          <p:cNvSpPr txBox="1"/>
          <p:nvPr/>
        </p:nvSpPr>
        <p:spPr>
          <a:xfrm>
            <a:off x="6658373" y="4000885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3"/>
                </a:solidFill>
              </a:rPr>
              <a:t>**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0831A40E-D1F9-2044-AF2C-A4CD22C0CE21}"/>
              </a:ext>
            </a:extLst>
          </p:cNvPr>
          <p:cNvSpPr txBox="1"/>
          <p:nvPr/>
        </p:nvSpPr>
        <p:spPr>
          <a:xfrm>
            <a:off x="7447299" y="4000886"/>
            <a:ext cx="563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3"/>
                </a:solidFill>
              </a:rPr>
              <a:t>***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A355A326-2F43-D546-9A25-4A593A94945F}"/>
              </a:ext>
            </a:extLst>
          </p:cNvPr>
          <p:cNvSpPr txBox="1"/>
          <p:nvPr/>
        </p:nvSpPr>
        <p:spPr>
          <a:xfrm>
            <a:off x="1734058" y="3853572"/>
            <a:ext cx="563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2"/>
                </a:solidFill>
              </a:rPr>
              <a:t>*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06568CFC-ED3F-D949-A2E5-525D69D0153F}"/>
              </a:ext>
            </a:extLst>
          </p:cNvPr>
          <p:cNvSpPr txBox="1"/>
          <p:nvPr/>
        </p:nvSpPr>
        <p:spPr>
          <a:xfrm>
            <a:off x="11424917" y="3860213"/>
            <a:ext cx="562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2"/>
                </a:solidFill>
              </a:rPr>
              <a:t>*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0E967D36-5374-E447-8864-97B1602BAECC}"/>
              </a:ext>
            </a:extLst>
          </p:cNvPr>
          <p:cNvSpPr txBox="1"/>
          <p:nvPr/>
        </p:nvSpPr>
        <p:spPr>
          <a:xfrm>
            <a:off x="10705565" y="3860215"/>
            <a:ext cx="267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accent2"/>
                </a:solidFill>
              </a:rPr>
              <a:t>*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D0BED02A-45BB-D543-83F2-C85BDAB02E2F}"/>
              </a:ext>
            </a:extLst>
          </p:cNvPr>
          <p:cNvSpPr txBox="1"/>
          <p:nvPr/>
        </p:nvSpPr>
        <p:spPr>
          <a:xfrm>
            <a:off x="11424917" y="4014103"/>
            <a:ext cx="562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solidFill>
                  <a:schemeClr val="accent3"/>
                </a:solidFill>
              </a:rPr>
              <a:t>*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44162480-7F71-A042-827A-D3D797264948}"/>
              </a:ext>
            </a:extLst>
          </p:cNvPr>
          <p:cNvSpPr txBox="1"/>
          <p:nvPr/>
        </p:nvSpPr>
        <p:spPr>
          <a:xfrm>
            <a:off x="9993480" y="6193297"/>
            <a:ext cx="23157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/>
              <a:t>Comparison</a:t>
            </a:r>
            <a:r>
              <a:rPr lang="fr-FR" sz="1000" dirty="0"/>
              <a:t> </a:t>
            </a:r>
            <a:r>
              <a:rPr lang="fr-FR" sz="1000" dirty="0" err="1"/>
              <a:t>with</a:t>
            </a:r>
            <a:r>
              <a:rPr lang="fr-FR" sz="1000" dirty="0"/>
              <a:t> White non-</a:t>
            </a:r>
            <a:r>
              <a:rPr lang="fr-FR" sz="1000" dirty="0" err="1"/>
              <a:t>Hispanic</a:t>
            </a:r>
            <a:r>
              <a:rPr lang="fr-FR" sz="1000" dirty="0"/>
              <a:t>: </a:t>
            </a:r>
          </a:p>
          <a:p>
            <a:r>
              <a:rPr lang="fr-FR" sz="1000" dirty="0">
                <a:solidFill>
                  <a:schemeClr val="accent2"/>
                </a:solidFill>
              </a:rPr>
              <a:t> </a:t>
            </a:r>
            <a:r>
              <a:rPr lang="fr-FR" sz="1000" dirty="0"/>
              <a:t>*    p&lt;0.05      **  p&lt;0.01      *** p&lt;0.001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3FB263B2-A0F7-504F-A799-5F69D3978B5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31147" y="3365218"/>
            <a:ext cx="3960000" cy="289755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B6D8DF5C-0AFB-F24E-9A61-BCC3D564D1C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31147" y="252116"/>
            <a:ext cx="3960000" cy="28975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744E2DA1-5377-2246-824C-D0F3ED87FCAC}"/>
              </a:ext>
            </a:extLst>
          </p:cNvPr>
          <p:cNvSpPr/>
          <p:nvPr/>
        </p:nvSpPr>
        <p:spPr>
          <a:xfrm>
            <a:off x="1702166" y="6478230"/>
            <a:ext cx="868533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/>
              <a:t>Appendix </a:t>
            </a:r>
            <a:r>
              <a:rPr lang="fr-FR" sz="2000" b="1" dirty="0"/>
              <a:t>2- </a:t>
            </a:r>
            <a:r>
              <a:rPr lang="fr-FR" sz="2000" b="1" dirty="0" err="1"/>
              <a:t>Analgesia</a:t>
            </a:r>
            <a:r>
              <a:rPr lang="fr-FR" sz="2000" b="1" dirty="0"/>
              <a:t> </a:t>
            </a:r>
            <a:r>
              <a:rPr lang="fr-FR" sz="2000" b="1" dirty="0" err="1"/>
              <a:t>modalities</a:t>
            </a:r>
            <a:r>
              <a:rPr lang="fr-FR" sz="2000" b="1" dirty="0"/>
              <a:t> by race/</a:t>
            </a:r>
            <a:r>
              <a:rPr lang="fr-FR" sz="2000" b="1" dirty="0" err="1"/>
              <a:t>ethnicity</a:t>
            </a:r>
            <a:r>
              <a:rPr lang="fr-FR" sz="2000" b="1" dirty="0"/>
              <a:t> </a:t>
            </a:r>
            <a:r>
              <a:rPr lang="fr-FR" sz="2000" b="1" dirty="0" err="1"/>
              <a:t>stratified</a:t>
            </a:r>
            <a:r>
              <a:rPr lang="fr-FR" sz="2000" b="1" dirty="0"/>
              <a:t> by initial pain score </a:t>
            </a:r>
          </a:p>
        </p:txBody>
      </p:sp>
    </p:spTree>
    <p:extLst>
      <p:ext uri="{BB962C8B-B14F-4D97-AF65-F5344CB8AC3E}">
        <p14:creationId xmlns:p14="http://schemas.microsoft.com/office/powerpoint/2010/main" val="201566374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0</TotalTime>
  <Words>82</Words>
  <Application>Microsoft Macintosh PowerPoint</Application>
  <PresentationFormat>Grand écran</PresentationFormat>
  <Paragraphs>3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ain Guedj</dc:creator>
  <cp:lastModifiedBy>Romain Guedj</cp:lastModifiedBy>
  <cp:revision>33</cp:revision>
  <dcterms:created xsi:type="dcterms:W3CDTF">2020-05-05T09:51:24Z</dcterms:created>
  <dcterms:modified xsi:type="dcterms:W3CDTF">2021-06-16T07:45:19Z</dcterms:modified>
</cp:coreProperties>
</file>